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9" r:id="rId2"/>
  </p:sldIdLst>
  <p:sldSz cx="7589838" cy="106981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DeFalco" initials="TAD" lastIdx="9" clrIdx="0">
    <p:extLst/>
  </p:cmAuthor>
  <p:cmAuthor id="2" name="Christine" initials="C" lastIdx="3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9933"/>
    <a:srgbClr val="FF6600"/>
    <a:srgbClr val="00009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51" autoAdjust="0"/>
    <p:restoredTop sz="94660"/>
  </p:normalViewPr>
  <p:slideViewPr>
    <p:cSldViewPr snapToGrid="0">
      <p:cViewPr>
        <p:scale>
          <a:sx n="80" d="100"/>
          <a:sy n="80" d="100"/>
        </p:scale>
        <p:origin x="-1074" y="156"/>
      </p:cViewPr>
      <p:guideLst>
        <p:guide orient="horz" pos="3369"/>
        <p:guide pos="239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4AF71-6B0D-4268-8DE5-E904D13FBA94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B464A9-5B19-4301-BCA5-F20F7B3D9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27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238" y="1750834"/>
            <a:ext cx="6451362" cy="3724546"/>
          </a:xfrm>
        </p:spPr>
        <p:txBody>
          <a:bodyPr anchor="b"/>
          <a:lstStyle>
            <a:lvl1pPr algn="ctr"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8730" y="5619013"/>
            <a:ext cx="5692379" cy="2582912"/>
          </a:xfrm>
        </p:spPr>
        <p:txBody>
          <a:bodyPr/>
          <a:lstStyle>
            <a:lvl1pPr marL="0" indent="0" algn="ctr">
              <a:buNone/>
              <a:defRPr sz="1992"/>
            </a:lvl1pPr>
            <a:lvl2pPr marL="379476" indent="0" algn="ctr">
              <a:buNone/>
              <a:defRPr sz="1660"/>
            </a:lvl2pPr>
            <a:lvl3pPr marL="758952" indent="0" algn="ctr">
              <a:buNone/>
              <a:defRPr sz="1494"/>
            </a:lvl3pPr>
            <a:lvl4pPr marL="1138428" indent="0" algn="ctr">
              <a:buNone/>
              <a:defRPr sz="1328"/>
            </a:lvl4pPr>
            <a:lvl5pPr marL="1517904" indent="0" algn="ctr">
              <a:buNone/>
              <a:defRPr sz="1328"/>
            </a:lvl5pPr>
            <a:lvl6pPr marL="1897380" indent="0" algn="ctr">
              <a:buNone/>
              <a:defRPr sz="1328"/>
            </a:lvl6pPr>
            <a:lvl7pPr marL="2276856" indent="0" algn="ctr">
              <a:buNone/>
              <a:defRPr sz="1328"/>
            </a:lvl7pPr>
            <a:lvl8pPr marL="2656332" indent="0" algn="ctr">
              <a:buNone/>
              <a:defRPr sz="1328"/>
            </a:lvl8pPr>
            <a:lvl9pPr marL="3035808" indent="0" algn="ctr">
              <a:buNone/>
              <a:defRPr sz="13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3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67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31478" y="569578"/>
            <a:ext cx="1636559" cy="90661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802" y="569578"/>
            <a:ext cx="4814803" cy="90661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6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849" y="2667115"/>
            <a:ext cx="6546235" cy="4450138"/>
          </a:xfrm>
        </p:spPr>
        <p:txBody>
          <a:bodyPr anchor="b"/>
          <a:lstStyle>
            <a:lvl1pPr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849" y="7159353"/>
            <a:ext cx="6546235" cy="2340222"/>
          </a:xfrm>
        </p:spPr>
        <p:txBody>
          <a:bodyPr/>
          <a:lstStyle>
            <a:lvl1pPr marL="0" indent="0">
              <a:buNone/>
              <a:defRPr sz="1992">
                <a:solidFill>
                  <a:schemeClr val="tx1"/>
                </a:solidFill>
              </a:defRPr>
            </a:lvl1pPr>
            <a:lvl2pPr marL="379476" indent="0">
              <a:buNone/>
              <a:defRPr sz="1660">
                <a:solidFill>
                  <a:schemeClr val="tx1">
                    <a:tint val="75000"/>
                  </a:schemeClr>
                </a:solidFill>
              </a:defRPr>
            </a:lvl2pPr>
            <a:lvl3pPr marL="758952" indent="0">
              <a:buNone/>
              <a:defRPr sz="1494">
                <a:solidFill>
                  <a:schemeClr val="tx1">
                    <a:tint val="75000"/>
                  </a:schemeClr>
                </a:solidFill>
              </a:defRPr>
            </a:lvl3pPr>
            <a:lvl4pPr marL="113842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4pPr>
            <a:lvl5pPr marL="1517904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5pPr>
            <a:lvl6pPr marL="1897380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6pPr>
            <a:lvl7pPr marL="2276856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7pPr>
            <a:lvl8pPr marL="2656332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8pPr>
            <a:lvl9pPr marL="303580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801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356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9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569580"/>
            <a:ext cx="6546235" cy="20678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791" y="2622536"/>
            <a:ext cx="3210857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791" y="3907801"/>
            <a:ext cx="3210857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2356" y="2622536"/>
            <a:ext cx="3226670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2356" y="3907801"/>
            <a:ext cx="3226670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2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3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6670" y="1540340"/>
            <a:ext cx="3842355" cy="7602630"/>
          </a:xfrm>
        </p:spPr>
        <p:txBody>
          <a:bodyPr/>
          <a:lstStyle>
            <a:lvl1pPr>
              <a:defRPr sz="2656"/>
            </a:lvl1pPr>
            <a:lvl2pPr>
              <a:defRPr sz="2324"/>
            </a:lvl2pPr>
            <a:lvl3pPr>
              <a:defRPr sz="1992"/>
            </a:lvl3pPr>
            <a:lvl4pPr>
              <a:defRPr sz="1660"/>
            </a:lvl4pPr>
            <a:lvl5pPr>
              <a:defRPr sz="1660"/>
            </a:lvl5pPr>
            <a:lvl6pPr>
              <a:defRPr sz="1660"/>
            </a:lvl6pPr>
            <a:lvl7pPr>
              <a:defRPr sz="1660"/>
            </a:lvl7pPr>
            <a:lvl8pPr>
              <a:defRPr sz="1660"/>
            </a:lvl8pPr>
            <a:lvl9pPr>
              <a:defRPr sz="16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7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6670" y="1540340"/>
            <a:ext cx="3842355" cy="7602630"/>
          </a:xfrm>
        </p:spPr>
        <p:txBody>
          <a:bodyPr anchor="t"/>
          <a:lstStyle>
            <a:lvl1pPr marL="0" indent="0">
              <a:buNone/>
              <a:defRPr sz="2656"/>
            </a:lvl1pPr>
            <a:lvl2pPr marL="379476" indent="0">
              <a:buNone/>
              <a:defRPr sz="2324"/>
            </a:lvl2pPr>
            <a:lvl3pPr marL="758952" indent="0">
              <a:buNone/>
              <a:defRPr sz="1992"/>
            </a:lvl3pPr>
            <a:lvl4pPr marL="1138428" indent="0">
              <a:buNone/>
              <a:defRPr sz="1660"/>
            </a:lvl4pPr>
            <a:lvl5pPr marL="1517904" indent="0">
              <a:buNone/>
              <a:defRPr sz="1660"/>
            </a:lvl5pPr>
            <a:lvl6pPr marL="1897380" indent="0">
              <a:buNone/>
              <a:defRPr sz="1660"/>
            </a:lvl6pPr>
            <a:lvl7pPr marL="2276856" indent="0">
              <a:buNone/>
              <a:defRPr sz="1660"/>
            </a:lvl7pPr>
            <a:lvl8pPr marL="2656332" indent="0">
              <a:buNone/>
              <a:defRPr sz="1660"/>
            </a:lvl8pPr>
            <a:lvl9pPr marL="3035808" indent="0">
              <a:buNone/>
              <a:defRPr sz="16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1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802" y="569580"/>
            <a:ext cx="6546235" cy="2067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802" y="2847891"/>
            <a:ext cx="6546235" cy="6787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801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4134" y="9915615"/>
            <a:ext cx="2561570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60323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0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8952" rtl="0" eaLnBrk="1" latinLnBrk="0" hangingPunct="1">
        <a:lnSpc>
          <a:spcPct val="90000"/>
        </a:lnSpc>
        <a:spcBef>
          <a:spcPct val="0"/>
        </a:spcBef>
        <a:buNone/>
        <a:defRPr sz="36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738" indent="-189738" algn="l" defTabSz="758952" rtl="0" eaLnBrk="1" latinLnBrk="0" hangingPunct="1">
        <a:lnSpc>
          <a:spcPct val="90000"/>
        </a:lnSpc>
        <a:spcBef>
          <a:spcPts val="830"/>
        </a:spcBef>
        <a:buFont typeface="Arial" panose="020B0604020202020204" pitchFamily="34" charset="0"/>
        <a:buChar char="•"/>
        <a:defRPr sz="2324" kern="1200">
          <a:solidFill>
            <a:schemeClr val="tx1"/>
          </a:solidFill>
          <a:latin typeface="+mn-lt"/>
          <a:ea typeface="+mn-ea"/>
          <a:cs typeface="+mn-cs"/>
        </a:defRPr>
      </a:lvl1pPr>
      <a:lvl2pPr marL="56921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2" kern="1200">
          <a:solidFill>
            <a:schemeClr val="tx1"/>
          </a:solidFill>
          <a:latin typeface="+mn-lt"/>
          <a:ea typeface="+mn-ea"/>
          <a:cs typeface="+mn-cs"/>
        </a:defRPr>
      </a:lvl2pPr>
      <a:lvl3pPr marL="94869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32816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707642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2087118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46659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84607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22554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1pPr>
      <a:lvl2pPr marL="37947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2pPr>
      <a:lvl3pPr marL="75895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3pPr>
      <a:lvl4pPr marL="113842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517904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189738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27685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65633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03580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3"/>
          <p:cNvSpPr>
            <a:spLocks noGrp="1"/>
          </p:cNvSpPr>
          <p:nvPr>
            <p:ph type="title"/>
          </p:nvPr>
        </p:nvSpPr>
        <p:spPr>
          <a:xfrm>
            <a:off x="137319" y="6802659"/>
            <a:ext cx="7315200" cy="1031579"/>
          </a:xfrm>
        </p:spPr>
        <p:txBody>
          <a:bodyPr anchor="t">
            <a:normAutofit fontScale="90000"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. (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calization of ERF8 wildtype and L176A L178A mutant variant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benthamia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showing protein expression of HA-tagged </a:t>
            </a:r>
            <a:r>
              <a:rPr lang="en-CA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RF8 </a:t>
            </a:r>
            <a:r>
              <a:rPr lang="en-CA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L176A, L178A </a:t>
            </a:r>
            <a:r>
              <a:rPr lang="en-CA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) in </a:t>
            </a:r>
            <a:r>
              <a:rPr lang="en-CA" alt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benthamiana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compared to that of ERF8 wildtype (W).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grobacterium expressing the silencing suppressor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ro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was used as negative control (-).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ro from tobacco etch virus (TEV) was co-expressed in all transient assays to reduce gene silencing. Arrow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indicates the expected molecular weight of ERF8-HA.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PI = days post inocula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1835348" y="2324896"/>
            <a:ext cx="3683453" cy="1828800"/>
            <a:chOff x="1671226" y="742949"/>
            <a:chExt cx="3683453" cy="18288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71226" y="742949"/>
              <a:ext cx="1828800" cy="182880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25879" y="742949"/>
              <a:ext cx="1828800" cy="1828800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1991285" y="750198"/>
              <a:ext cx="118868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b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FP-ERF8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663039" y="750198"/>
              <a:ext cx="1554480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b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FP-ERF8</a:t>
              </a:r>
              <a:r>
                <a:rPr lang="en-US" sz="1100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76A/L178A</a:t>
              </a:r>
              <a:endPara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1399944" y="1954631"/>
            <a:ext cx="869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453305" y="4627555"/>
            <a:ext cx="869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1" name="Group 20"/>
          <p:cNvGrpSpPr/>
          <p:nvPr/>
        </p:nvGrpSpPr>
        <p:grpSpPr>
          <a:xfrm>
            <a:off x="1747064" y="4753755"/>
            <a:ext cx="4372527" cy="1516822"/>
            <a:chOff x="2696725" y="3135485"/>
            <a:chExt cx="4372527" cy="1516822"/>
          </a:xfrm>
        </p:grpSpPr>
        <p:pic>
          <p:nvPicPr>
            <p:cNvPr id="22" name="Picture 2" descr="C:\Documents and Settings\Desveaux Lab\My Documents\Christine\2012\western\2012_05_30\2012_06_02\2012.6.1_0001.tif"/>
            <p:cNvPicPr>
              <a:picLocks noChangeAspect="1" noChangeArrowheads="1"/>
            </p:cNvPicPr>
            <p:nvPr/>
          </p:nvPicPr>
          <p:blipFill rotWithShape="1">
            <a:blip r:embed="rId4" cstate="print"/>
            <a:srcRect l="820" t="37780" r="17917" b="51182"/>
            <a:stretch/>
          </p:blipFill>
          <p:spPr bwMode="auto">
            <a:xfrm flipH="1">
              <a:off x="2807980" y="3670462"/>
              <a:ext cx="3318385" cy="49297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  <p:sp>
          <p:nvSpPr>
            <p:cNvPr id="23" name="TextBox 22"/>
            <p:cNvSpPr txBox="1"/>
            <p:nvPr/>
          </p:nvSpPr>
          <p:spPr>
            <a:xfrm>
              <a:off x="2706485" y="3422443"/>
              <a:ext cx="34977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dirty="0">
                  <a:latin typeface="Arial" panose="020B0604020202020204" pitchFamily="34" charset="0"/>
                  <a:cs typeface="Arial" panose="020B0604020202020204" pitchFamily="34" charset="0"/>
                </a:rPr>
                <a:t>   W          M     -         W          M     -    W          M    -   </a:t>
              </a:r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2902084" y="3423973"/>
              <a:ext cx="8635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4123748" y="3423973"/>
              <a:ext cx="8635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5139800" y="3423973"/>
              <a:ext cx="8635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2950981" y="3135485"/>
              <a:ext cx="29716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dirty="0">
                  <a:latin typeface="Arial" panose="020B0604020202020204" pitchFamily="34" charset="0"/>
                  <a:cs typeface="Arial" panose="020B0604020202020204" pitchFamily="34" charset="0"/>
                </a:rPr>
                <a:t> 1 DPI 	          3 DPI	              6 DPI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115477" y="3861253"/>
              <a:ext cx="641897" cy="2988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</a:t>
              </a:r>
              <a:r>
                <a:rPr lang="en-CA" sz="1100" dirty="0"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</a:p>
          </p:txBody>
        </p:sp>
        <p:pic>
          <p:nvPicPr>
            <p:cNvPr id="29" name="Picture 28" descr="C:\Documents and Settings\Desveaux Lab\My Documents\Christine\2012\western\2012_05_30\2012.5.30.tif"/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9406" t="30009" r="56538" b="67273"/>
            <a:stretch/>
          </p:blipFill>
          <p:spPr bwMode="auto">
            <a:xfrm>
              <a:off x="2807981" y="4220954"/>
              <a:ext cx="3318385" cy="4313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  <p:sp>
          <p:nvSpPr>
            <p:cNvPr id="30" name="TextBox 29"/>
            <p:cNvSpPr txBox="1"/>
            <p:nvPr/>
          </p:nvSpPr>
          <p:spPr>
            <a:xfrm>
              <a:off x="6141730" y="4346204"/>
              <a:ext cx="927522" cy="2988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endParaRPr lang="en-CA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Isosceles Triangle 35"/>
            <p:cNvSpPr/>
            <p:nvPr/>
          </p:nvSpPr>
          <p:spPr>
            <a:xfrm rot="5400000">
              <a:off x="2696725" y="3804078"/>
              <a:ext cx="72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415566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22</TotalTime>
  <Words>118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2. (A) Localization of ERF8 wildtype and L176A L178A mutant variant in N. benthamiana. (B) Western blot analysis showing protein expression of HA-tagged ERF8 L176A, L178A (M) in N. benthamiana compared to that of ERF8 wildtype (W).  Agrobacterium expressing the silencing suppressor Hc-Pro was used as negative control (-). Hc-Pro from tobacco etch virus (TEV) was co-expressed in all transient assays to reduce gene silencing. Arrow indicates the expected molecular weight of ERF8-HA. DPI = days post inoculation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</dc:creator>
  <cp:lastModifiedBy>moeder</cp:lastModifiedBy>
  <cp:revision>316</cp:revision>
  <dcterms:created xsi:type="dcterms:W3CDTF">2016-09-27T17:34:00Z</dcterms:created>
  <dcterms:modified xsi:type="dcterms:W3CDTF">2018-08-22T14:21:44Z</dcterms:modified>
</cp:coreProperties>
</file>